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59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iwen TAO (20617230)" userId="e74e6a04-9452-4ccc-a6e1-a1aef7a84d6a" providerId="ADAL" clId="{A45FB281-ED21-4C5B-ABEB-B09ABAC33B7D}"/>
    <pc:docChg chg="undo custSel addSld delSld modSld">
      <pc:chgData name="Yiwen TAO (20617230)" userId="e74e6a04-9452-4ccc-a6e1-a1aef7a84d6a" providerId="ADAL" clId="{A45FB281-ED21-4C5B-ABEB-B09ABAC33B7D}" dt="2024-10-30T07:31:51.438" v="142" actId="1076"/>
      <pc:docMkLst>
        <pc:docMk/>
      </pc:docMkLst>
      <pc:sldChg chg="addSp delSp modSp add">
        <pc:chgData name="Yiwen TAO (20617230)" userId="e74e6a04-9452-4ccc-a6e1-a1aef7a84d6a" providerId="ADAL" clId="{A45FB281-ED21-4C5B-ABEB-B09ABAC33B7D}" dt="2024-10-30T07:17:03.825" v="17"/>
        <pc:sldMkLst>
          <pc:docMk/>
          <pc:sldMk cId="922247321" sldId="256"/>
        </pc:sldMkLst>
        <pc:spChg chg="del">
          <ac:chgData name="Yiwen TAO (20617230)" userId="e74e6a04-9452-4ccc-a6e1-a1aef7a84d6a" providerId="ADAL" clId="{A45FB281-ED21-4C5B-ABEB-B09ABAC33B7D}" dt="2024-10-29T14:31:20.358" v="1" actId="478"/>
          <ac:spMkLst>
            <pc:docMk/>
            <pc:sldMk cId="922247321" sldId="256"/>
            <ac:spMk id="2" creationId="{EC1F9CBA-4A95-4385-9395-72F22A1BA5A3}"/>
          </ac:spMkLst>
        </pc:spChg>
        <pc:spChg chg="del">
          <ac:chgData name="Yiwen TAO (20617230)" userId="e74e6a04-9452-4ccc-a6e1-a1aef7a84d6a" providerId="ADAL" clId="{A45FB281-ED21-4C5B-ABEB-B09ABAC33B7D}" dt="2024-10-29T14:31:21.648" v="2" actId="478"/>
          <ac:spMkLst>
            <pc:docMk/>
            <pc:sldMk cId="922247321" sldId="256"/>
            <ac:spMk id="3" creationId="{8A86ACCA-EEA6-48E3-9613-A0BD2C5B2ECA}"/>
          </ac:spMkLst>
        </pc:spChg>
        <pc:spChg chg="add mod">
          <ac:chgData name="Yiwen TAO (20617230)" userId="e74e6a04-9452-4ccc-a6e1-a1aef7a84d6a" providerId="ADAL" clId="{A45FB281-ED21-4C5B-ABEB-B09ABAC33B7D}" dt="2024-10-30T07:14:32.407" v="16"/>
          <ac:spMkLst>
            <pc:docMk/>
            <pc:sldMk cId="922247321" sldId="256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17:03.825" v="17"/>
          <ac:picMkLst>
            <pc:docMk/>
            <pc:sldMk cId="922247321" sldId="256"/>
            <ac:picMk id="3" creationId="{7CA32490-5F9B-4F0D-844A-CA6D251854FE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36.696" v="18" actId="2696"/>
        <pc:sldMkLst>
          <pc:docMk/>
          <pc:sldMk cId="2291068284" sldId="257"/>
        </pc:sldMkLst>
      </pc:sldChg>
      <pc:sldChg chg="add del">
        <pc:chgData name="Yiwen TAO (20617230)" userId="e74e6a04-9452-4ccc-a6e1-a1aef7a84d6a" providerId="ADAL" clId="{A45FB281-ED21-4C5B-ABEB-B09ABAC33B7D}" dt="2024-10-30T07:17:44.506" v="36"/>
        <pc:sldMkLst>
          <pc:docMk/>
          <pc:sldMk cId="3800181734" sldId="257"/>
        </pc:sldMkLst>
      </pc:sldChg>
      <pc:sldChg chg="addSp delSp modSp add">
        <pc:chgData name="Yiwen TAO (20617230)" userId="e74e6a04-9452-4ccc-a6e1-a1aef7a84d6a" providerId="ADAL" clId="{A45FB281-ED21-4C5B-ABEB-B09ABAC33B7D}" dt="2024-10-30T07:19:32.604" v="65" actId="1076"/>
        <pc:sldMkLst>
          <pc:docMk/>
          <pc:sldMk cId="3936894140" sldId="257"/>
        </pc:sldMkLst>
        <pc:spChg chg="mod">
          <ac:chgData name="Yiwen TAO (20617230)" userId="e74e6a04-9452-4ccc-a6e1-a1aef7a84d6a" providerId="ADAL" clId="{A45FB281-ED21-4C5B-ABEB-B09ABAC33B7D}" dt="2024-10-30T07:19:23.657" v="62" actId="20577"/>
          <ac:spMkLst>
            <pc:docMk/>
            <pc:sldMk cId="3936894140" sldId="257"/>
            <ac:spMk id="4" creationId="{605B9555-71FF-4339-97A0-71DC58BA8863}"/>
          </ac:spMkLst>
        </pc:spChg>
        <pc:picChg chg="del">
          <ac:chgData name="Yiwen TAO (20617230)" userId="e74e6a04-9452-4ccc-a6e1-a1aef7a84d6a" providerId="ADAL" clId="{A45FB281-ED21-4C5B-ABEB-B09ABAC33B7D}" dt="2024-10-30T07:17:50.026" v="38" actId="478"/>
          <ac:picMkLst>
            <pc:docMk/>
            <pc:sldMk cId="3936894140" sldId="257"/>
            <ac:picMk id="3" creationId="{7CA32490-5F9B-4F0D-844A-CA6D251854FE}"/>
          </ac:picMkLst>
        </pc:picChg>
        <pc:picChg chg="add mod">
          <ac:chgData name="Yiwen TAO (20617230)" userId="e74e6a04-9452-4ccc-a6e1-a1aef7a84d6a" providerId="ADAL" clId="{A45FB281-ED21-4C5B-ABEB-B09ABAC33B7D}" dt="2024-10-30T07:19:32.604" v="65" actId="1076"/>
          <ac:picMkLst>
            <pc:docMk/>
            <pc:sldMk cId="3936894140" sldId="257"/>
            <ac:picMk id="5" creationId="{E6A00563-6144-42F7-868C-F1854C30F31F}"/>
          </ac:picMkLst>
        </pc:picChg>
      </pc:sldChg>
      <pc:sldChg chg="modSp add del">
        <pc:chgData name="Yiwen TAO (20617230)" userId="e74e6a04-9452-4ccc-a6e1-a1aef7a84d6a" providerId="ADAL" clId="{A45FB281-ED21-4C5B-ABEB-B09ABAC33B7D}" dt="2024-10-30T07:20:56.832" v="74" actId="2696"/>
        <pc:sldMkLst>
          <pc:docMk/>
          <pc:sldMk cId="2143216870" sldId="258"/>
        </pc:sldMkLst>
        <pc:spChg chg="mod">
          <ac:chgData name="Yiwen TAO (20617230)" userId="e74e6a04-9452-4ccc-a6e1-a1aef7a84d6a" providerId="ADAL" clId="{A45FB281-ED21-4C5B-ABEB-B09ABAC33B7D}" dt="2024-10-30T07:20:36.967" v="73" actId="108"/>
          <ac:spMkLst>
            <pc:docMk/>
            <pc:sldMk cId="2143216870" sldId="258"/>
            <ac:spMk id="4" creationId="{605B9555-71FF-4339-97A0-71DC58BA8863}"/>
          </ac:spMkLst>
        </pc:spChg>
      </pc:sldChg>
      <pc:sldChg chg="add del">
        <pc:chgData name="Yiwen TAO (20617230)" userId="e74e6a04-9452-4ccc-a6e1-a1aef7a84d6a" providerId="ADAL" clId="{A45FB281-ED21-4C5B-ABEB-B09ABAC33B7D}" dt="2024-10-30T07:17:36.706" v="19" actId="2696"/>
        <pc:sldMkLst>
          <pc:docMk/>
          <pc:sldMk cId="2207714500" sldId="258"/>
        </pc:sldMkLst>
      </pc:sldChg>
      <pc:sldChg chg="add del">
        <pc:chgData name="Yiwen TAO (20617230)" userId="e74e6a04-9452-4ccc-a6e1-a1aef7a84d6a" providerId="ADAL" clId="{A45FB281-ED21-4C5B-ABEB-B09ABAC33B7D}" dt="2024-10-30T07:17:44.026" v="35"/>
        <pc:sldMkLst>
          <pc:docMk/>
          <pc:sldMk cId="3409380829" sldId="258"/>
        </pc:sldMkLst>
      </pc:sldChg>
      <pc:sldChg chg="add del">
        <pc:chgData name="Yiwen TAO (20617230)" userId="e74e6a04-9452-4ccc-a6e1-a1aef7a84d6a" providerId="ADAL" clId="{A45FB281-ED21-4C5B-ABEB-B09ABAC33B7D}" dt="2024-10-30T07:17:36.706" v="20" actId="2696"/>
        <pc:sldMkLst>
          <pc:docMk/>
          <pc:sldMk cId="1136584103" sldId="259"/>
        </pc:sldMkLst>
      </pc:sldChg>
      <pc:sldChg chg="addSp delSp modSp add">
        <pc:chgData name="Yiwen TAO (20617230)" userId="e74e6a04-9452-4ccc-a6e1-a1aef7a84d6a" providerId="ADAL" clId="{A45FB281-ED21-4C5B-ABEB-B09ABAC33B7D}" dt="2024-10-30T07:21:54.717" v="81"/>
        <pc:sldMkLst>
          <pc:docMk/>
          <pc:sldMk cId="2508905601" sldId="259"/>
        </pc:sldMkLst>
        <pc:spChg chg="mod">
          <ac:chgData name="Yiwen TAO (20617230)" userId="e74e6a04-9452-4ccc-a6e1-a1aef7a84d6a" providerId="ADAL" clId="{A45FB281-ED21-4C5B-ABEB-B09ABAC33B7D}" dt="2024-10-30T07:21:14.587" v="78"/>
          <ac:spMkLst>
            <pc:docMk/>
            <pc:sldMk cId="2508905601" sldId="259"/>
            <ac:spMk id="4" creationId="{605B9555-71FF-4339-97A0-71DC58BA8863}"/>
          </ac:spMkLst>
        </pc:spChg>
        <pc:graphicFrameChg chg="add del mod">
          <ac:chgData name="Yiwen TAO (20617230)" userId="e74e6a04-9452-4ccc-a6e1-a1aef7a84d6a" providerId="ADAL" clId="{A45FB281-ED21-4C5B-ABEB-B09ABAC33B7D}" dt="2024-10-30T07:21:50.857" v="80" actId="478"/>
          <ac:graphicFrameMkLst>
            <pc:docMk/>
            <pc:sldMk cId="2508905601" sldId="259"/>
            <ac:graphicFrameMk id="2" creationId="{EB1AC35B-25A2-4886-8C6F-1B6348903B8C}"/>
          </ac:graphicFrameMkLst>
        </pc:graphicFrameChg>
        <pc:picChg chg="add mod">
          <ac:chgData name="Yiwen TAO (20617230)" userId="e74e6a04-9452-4ccc-a6e1-a1aef7a84d6a" providerId="ADAL" clId="{A45FB281-ED21-4C5B-ABEB-B09ABAC33B7D}" dt="2024-10-30T07:21:54.717" v="81"/>
          <ac:picMkLst>
            <pc:docMk/>
            <pc:sldMk cId="2508905601" sldId="259"/>
            <ac:picMk id="5" creationId="{FA0D81D0-ADC8-4220-A1E8-D260F7E16824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43.736" v="34"/>
        <pc:sldMkLst>
          <pc:docMk/>
          <pc:sldMk cId="2743242800" sldId="259"/>
        </pc:sldMkLst>
      </pc:sldChg>
      <pc:sldChg chg="addSp modSp add">
        <pc:chgData name="Yiwen TAO (20617230)" userId="e74e6a04-9452-4ccc-a6e1-a1aef7a84d6a" providerId="ADAL" clId="{A45FB281-ED21-4C5B-ABEB-B09ABAC33B7D}" dt="2024-10-30T07:23:18.538" v="88" actId="1076"/>
        <pc:sldMkLst>
          <pc:docMk/>
          <pc:sldMk cId="3180749586" sldId="260"/>
        </pc:sldMkLst>
        <pc:spChg chg="mod">
          <ac:chgData name="Yiwen TAO (20617230)" userId="e74e6a04-9452-4ccc-a6e1-a1aef7a84d6a" providerId="ADAL" clId="{A45FB281-ED21-4C5B-ABEB-B09ABAC33B7D}" dt="2024-10-30T07:22:27.889" v="85"/>
          <ac:spMkLst>
            <pc:docMk/>
            <pc:sldMk cId="3180749586" sldId="260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23:18.538" v="88" actId="1076"/>
          <ac:picMkLst>
            <pc:docMk/>
            <pc:sldMk cId="3180749586" sldId="260"/>
            <ac:picMk id="3" creationId="{005920FC-6373-4DB5-828C-950B15AC1D3B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36.706" v="21" actId="2696"/>
        <pc:sldMkLst>
          <pc:docMk/>
          <pc:sldMk cId="3271508665" sldId="260"/>
        </pc:sldMkLst>
      </pc:sldChg>
      <pc:sldChg chg="add del">
        <pc:chgData name="Yiwen TAO (20617230)" userId="e74e6a04-9452-4ccc-a6e1-a1aef7a84d6a" providerId="ADAL" clId="{A45FB281-ED21-4C5B-ABEB-B09ABAC33B7D}" dt="2024-10-30T07:17:43.536" v="33"/>
        <pc:sldMkLst>
          <pc:docMk/>
          <pc:sldMk cId="3531291609" sldId="260"/>
        </pc:sldMkLst>
      </pc:sldChg>
      <pc:sldChg chg="add del">
        <pc:chgData name="Yiwen TAO (20617230)" userId="e74e6a04-9452-4ccc-a6e1-a1aef7a84d6a" providerId="ADAL" clId="{A45FB281-ED21-4C5B-ABEB-B09ABAC33B7D}" dt="2024-10-30T07:17:36.716" v="22" actId="2696"/>
        <pc:sldMkLst>
          <pc:docMk/>
          <pc:sldMk cId="38728400" sldId="261"/>
        </pc:sldMkLst>
      </pc:sldChg>
      <pc:sldChg chg="addSp modSp add">
        <pc:chgData name="Yiwen TAO (20617230)" userId="e74e6a04-9452-4ccc-a6e1-a1aef7a84d6a" providerId="ADAL" clId="{A45FB281-ED21-4C5B-ABEB-B09ABAC33B7D}" dt="2024-10-30T07:24:17.907" v="93"/>
        <pc:sldMkLst>
          <pc:docMk/>
          <pc:sldMk cId="3091754745" sldId="261"/>
        </pc:sldMkLst>
        <pc:spChg chg="mod">
          <ac:chgData name="Yiwen TAO (20617230)" userId="e74e6a04-9452-4ccc-a6e1-a1aef7a84d6a" providerId="ADAL" clId="{A45FB281-ED21-4C5B-ABEB-B09ABAC33B7D}" dt="2024-10-30T07:24:15.658" v="92"/>
          <ac:spMkLst>
            <pc:docMk/>
            <pc:sldMk cId="3091754745" sldId="261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24:17.907" v="93"/>
          <ac:picMkLst>
            <pc:docMk/>
            <pc:sldMk cId="3091754745" sldId="261"/>
            <ac:picMk id="3" creationId="{AB00B8A9-5599-4567-B850-CEA607929AAD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36.716" v="23" actId="2696"/>
        <pc:sldMkLst>
          <pc:docMk/>
          <pc:sldMk cId="1658127497" sldId="262"/>
        </pc:sldMkLst>
      </pc:sldChg>
      <pc:sldChg chg="addSp modSp add">
        <pc:chgData name="Yiwen TAO (20617230)" userId="e74e6a04-9452-4ccc-a6e1-a1aef7a84d6a" providerId="ADAL" clId="{A45FB281-ED21-4C5B-ABEB-B09ABAC33B7D}" dt="2024-10-30T07:25:09.988" v="102" actId="1076"/>
        <pc:sldMkLst>
          <pc:docMk/>
          <pc:sldMk cId="2283479796" sldId="262"/>
        </pc:sldMkLst>
        <pc:spChg chg="mod">
          <ac:chgData name="Yiwen TAO (20617230)" userId="e74e6a04-9452-4ccc-a6e1-a1aef7a84d6a" providerId="ADAL" clId="{A45FB281-ED21-4C5B-ABEB-B09ABAC33B7D}" dt="2024-10-30T07:25:02.558" v="97"/>
          <ac:spMkLst>
            <pc:docMk/>
            <pc:sldMk cId="2283479796" sldId="262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25:09.988" v="102" actId="1076"/>
          <ac:picMkLst>
            <pc:docMk/>
            <pc:sldMk cId="2283479796" sldId="262"/>
            <ac:picMk id="3" creationId="{F9EFD128-2F76-4D51-9380-FC2AD82FAA37}"/>
          </ac:picMkLst>
        </pc:picChg>
      </pc:sldChg>
      <pc:sldChg chg="addSp modSp add">
        <pc:chgData name="Yiwen TAO (20617230)" userId="e74e6a04-9452-4ccc-a6e1-a1aef7a84d6a" providerId="ADAL" clId="{A45FB281-ED21-4C5B-ABEB-B09ABAC33B7D}" dt="2024-10-30T07:26:33.188" v="109" actId="1076"/>
        <pc:sldMkLst>
          <pc:docMk/>
          <pc:sldMk cId="1283792395" sldId="263"/>
        </pc:sldMkLst>
        <pc:spChg chg="mod">
          <ac:chgData name="Yiwen TAO (20617230)" userId="e74e6a04-9452-4ccc-a6e1-a1aef7a84d6a" providerId="ADAL" clId="{A45FB281-ED21-4C5B-ABEB-B09ABAC33B7D}" dt="2024-10-30T07:25:45.388" v="106"/>
          <ac:spMkLst>
            <pc:docMk/>
            <pc:sldMk cId="1283792395" sldId="263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26:33.188" v="109" actId="1076"/>
          <ac:picMkLst>
            <pc:docMk/>
            <pc:sldMk cId="1283792395" sldId="263"/>
            <ac:picMk id="3" creationId="{A2DCE50D-0DE5-4EF2-AB32-A7CB1E2A1FA5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36.725" v="24" actId="2696"/>
        <pc:sldMkLst>
          <pc:docMk/>
          <pc:sldMk cId="3535978093" sldId="263"/>
        </pc:sldMkLst>
      </pc:sldChg>
      <pc:sldChg chg="add del">
        <pc:chgData name="Yiwen TAO (20617230)" userId="e74e6a04-9452-4ccc-a6e1-a1aef7a84d6a" providerId="ADAL" clId="{A45FB281-ED21-4C5B-ABEB-B09ABAC33B7D}" dt="2024-10-30T07:17:36.727" v="25" actId="2696"/>
        <pc:sldMkLst>
          <pc:docMk/>
          <pc:sldMk cId="1226652446" sldId="264"/>
        </pc:sldMkLst>
      </pc:sldChg>
      <pc:sldChg chg="addSp modSp add">
        <pc:chgData name="Yiwen TAO (20617230)" userId="e74e6a04-9452-4ccc-a6e1-a1aef7a84d6a" providerId="ADAL" clId="{A45FB281-ED21-4C5B-ABEB-B09ABAC33B7D}" dt="2024-10-30T07:27:41.698" v="116" actId="1076"/>
        <pc:sldMkLst>
          <pc:docMk/>
          <pc:sldMk cId="3250409287" sldId="264"/>
        </pc:sldMkLst>
        <pc:spChg chg="mod">
          <ac:chgData name="Yiwen TAO (20617230)" userId="e74e6a04-9452-4ccc-a6e1-a1aef7a84d6a" providerId="ADAL" clId="{A45FB281-ED21-4C5B-ABEB-B09ABAC33B7D}" dt="2024-10-30T07:27:17.598" v="113"/>
          <ac:spMkLst>
            <pc:docMk/>
            <pc:sldMk cId="3250409287" sldId="264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27:41.698" v="116" actId="1076"/>
          <ac:picMkLst>
            <pc:docMk/>
            <pc:sldMk cId="3250409287" sldId="264"/>
            <ac:picMk id="3" creationId="{884E281C-841F-41B8-8CEF-39FAF864DC25}"/>
          </ac:picMkLst>
        </pc:picChg>
      </pc:sldChg>
      <pc:sldChg chg="addSp modSp add">
        <pc:chgData name="Yiwen TAO (20617230)" userId="e74e6a04-9452-4ccc-a6e1-a1aef7a84d6a" providerId="ADAL" clId="{A45FB281-ED21-4C5B-ABEB-B09ABAC33B7D}" dt="2024-10-30T07:28:37.758" v="121"/>
        <pc:sldMkLst>
          <pc:docMk/>
          <pc:sldMk cId="1238171747" sldId="265"/>
        </pc:sldMkLst>
        <pc:spChg chg="mod">
          <ac:chgData name="Yiwen TAO (20617230)" userId="e74e6a04-9452-4ccc-a6e1-a1aef7a84d6a" providerId="ADAL" clId="{A45FB281-ED21-4C5B-ABEB-B09ABAC33B7D}" dt="2024-10-30T07:28:23.039" v="120"/>
          <ac:spMkLst>
            <pc:docMk/>
            <pc:sldMk cId="1238171747" sldId="265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28:37.758" v="121"/>
          <ac:picMkLst>
            <pc:docMk/>
            <pc:sldMk cId="1238171747" sldId="265"/>
            <ac:picMk id="3" creationId="{2A52018D-947C-4036-915C-44C137D80AE3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36.727" v="26" actId="2696"/>
        <pc:sldMkLst>
          <pc:docMk/>
          <pc:sldMk cId="1572919620" sldId="265"/>
        </pc:sldMkLst>
      </pc:sldChg>
      <pc:sldChg chg="addSp modSp add">
        <pc:chgData name="Yiwen TAO (20617230)" userId="e74e6a04-9452-4ccc-a6e1-a1aef7a84d6a" providerId="ADAL" clId="{A45FB281-ED21-4C5B-ABEB-B09ABAC33B7D}" dt="2024-10-30T07:30:02.508" v="128" actId="1076"/>
        <pc:sldMkLst>
          <pc:docMk/>
          <pc:sldMk cId="2155970147" sldId="266"/>
        </pc:sldMkLst>
        <pc:spChg chg="mod">
          <ac:chgData name="Yiwen TAO (20617230)" userId="e74e6a04-9452-4ccc-a6e1-a1aef7a84d6a" providerId="ADAL" clId="{A45FB281-ED21-4C5B-ABEB-B09ABAC33B7D}" dt="2024-10-30T07:29:20.838" v="125"/>
          <ac:spMkLst>
            <pc:docMk/>
            <pc:sldMk cId="2155970147" sldId="266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30:02.508" v="128" actId="1076"/>
          <ac:picMkLst>
            <pc:docMk/>
            <pc:sldMk cId="2155970147" sldId="266"/>
            <ac:picMk id="3" creationId="{CF03D43E-1B42-41F2-A025-6115B970CB12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36.727" v="27" actId="2696"/>
        <pc:sldMkLst>
          <pc:docMk/>
          <pc:sldMk cId="2485698834" sldId="266"/>
        </pc:sldMkLst>
      </pc:sldChg>
      <pc:sldChg chg="addSp modSp add">
        <pc:chgData name="Yiwen TAO (20617230)" userId="e74e6a04-9452-4ccc-a6e1-a1aef7a84d6a" providerId="ADAL" clId="{A45FB281-ED21-4C5B-ABEB-B09ABAC33B7D}" dt="2024-10-30T07:30:56.659" v="135" actId="1076"/>
        <pc:sldMkLst>
          <pc:docMk/>
          <pc:sldMk cId="144447744" sldId="267"/>
        </pc:sldMkLst>
        <pc:spChg chg="mod">
          <ac:chgData name="Yiwen TAO (20617230)" userId="e74e6a04-9452-4ccc-a6e1-a1aef7a84d6a" providerId="ADAL" clId="{A45FB281-ED21-4C5B-ABEB-B09ABAC33B7D}" dt="2024-10-30T07:30:28.258" v="132"/>
          <ac:spMkLst>
            <pc:docMk/>
            <pc:sldMk cId="144447744" sldId="267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30:56.659" v="135" actId="1076"/>
          <ac:picMkLst>
            <pc:docMk/>
            <pc:sldMk cId="144447744" sldId="267"/>
            <ac:picMk id="3" creationId="{2339F744-F564-473B-B4F1-424213335E0D}"/>
          </ac:picMkLst>
        </pc:picChg>
      </pc:sldChg>
      <pc:sldChg chg="add del">
        <pc:chgData name="Yiwen TAO (20617230)" userId="e74e6a04-9452-4ccc-a6e1-a1aef7a84d6a" providerId="ADAL" clId="{A45FB281-ED21-4C5B-ABEB-B09ABAC33B7D}" dt="2024-10-30T07:17:36.736" v="28" actId="2696"/>
        <pc:sldMkLst>
          <pc:docMk/>
          <pc:sldMk cId="2731629871" sldId="267"/>
        </pc:sldMkLst>
      </pc:sldChg>
      <pc:sldChg chg="addSp modSp add">
        <pc:chgData name="Yiwen TAO (20617230)" userId="e74e6a04-9452-4ccc-a6e1-a1aef7a84d6a" providerId="ADAL" clId="{A45FB281-ED21-4C5B-ABEB-B09ABAC33B7D}" dt="2024-10-30T07:31:51.438" v="142" actId="1076"/>
        <pc:sldMkLst>
          <pc:docMk/>
          <pc:sldMk cId="3682821071" sldId="268"/>
        </pc:sldMkLst>
        <pc:spChg chg="mod">
          <ac:chgData name="Yiwen TAO (20617230)" userId="e74e6a04-9452-4ccc-a6e1-a1aef7a84d6a" providerId="ADAL" clId="{A45FB281-ED21-4C5B-ABEB-B09ABAC33B7D}" dt="2024-10-30T07:31:20.898" v="139"/>
          <ac:spMkLst>
            <pc:docMk/>
            <pc:sldMk cId="3682821071" sldId="268"/>
            <ac:spMk id="4" creationId="{605B9555-71FF-4339-97A0-71DC58BA8863}"/>
          </ac:spMkLst>
        </pc:spChg>
        <pc:picChg chg="add mod">
          <ac:chgData name="Yiwen TAO (20617230)" userId="e74e6a04-9452-4ccc-a6e1-a1aef7a84d6a" providerId="ADAL" clId="{A45FB281-ED21-4C5B-ABEB-B09ABAC33B7D}" dt="2024-10-30T07:31:51.438" v="142" actId="1076"/>
          <ac:picMkLst>
            <pc:docMk/>
            <pc:sldMk cId="3682821071" sldId="268"/>
            <ac:picMk id="3" creationId="{5FAF9B33-FE76-4BCB-9D0C-3C5652C2BD9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E872BE-B92B-4FBE-8B5B-C5EBC74032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E11D8B3-8B73-48A7-983C-F4E1FA8DC6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FAFC3F7-650E-4DB1-BDC3-9473E6013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217388-7888-40F0-A3D5-143C04C2D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003790-C322-4153-9A11-1A6ECB76C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072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784849-45F1-4759-8358-7E277B5A67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90391AA-8378-4FE5-9085-A56B3579DF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4556AD-A9F2-425D-87A8-ECB2E66AB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B1C576-36C5-46EC-9165-4BF03E374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609737-FF8F-40C7-94B8-37508ED9A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555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3CD5A2E-C3D5-488A-8C5A-9847DF7E29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792F08A-1413-4819-84DD-81D3275413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ABD849-99B3-47DF-9174-BCB72C93E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2C3A7C-4E40-4CE3-A4BC-9998945A7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B24DA9-27C4-4B14-AB38-9EE847DF0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180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261ED1-C0D7-4314-9A01-B17B8B542D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C96B90-8EBC-47ED-915E-D1FC9CB56B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07FD52-064F-409D-909F-F2C7C5229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012072-6797-4061-9E92-F8790959C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5AC14D-0664-449C-AF79-4844E465F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202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762321-66E1-4769-83CE-7821827EBB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4EAC7C-68E4-44E9-B67E-0730532E40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D70B86-D83C-4BEA-893E-B0A10D3CD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345CBA-8C36-48AA-9A85-EA8E21700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81F2DF-9970-4214-B7CC-8C6B8FC54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289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985BAA-73AB-4282-893F-1EE6BCC5D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FD3F1D-1356-42C8-95D9-4A7C11D4B9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6C406C-54FA-4525-999A-EAFFF00E3D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041365-4299-44BA-90F0-ED9FBB143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1AFF3BA-330E-4E55-94A2-B028536BF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3618777-2D24-45E5-8A63-514955D03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2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B7D183-EAB1-4852-9904-3AA7A4C09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FB2790-769C-4E8A-A77E-A58101A27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6657D7A-8C38-4099-9676-A85C0B239F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A770904-38CF-4BF4-98EB-5C2ABD22A5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1EE7796-74AC-4CEE-B5DA-829E6F89E5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6E7CB86-EAFC-46C4-BB97-D55B7591A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7C242BB-5A51-4546-9761-53737ADC4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560AB42-7252-4DA8-92B2-49F18F4EC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228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285868-5CC1-40F7-8019-01CEAEF88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A96272B-51DF-480C-B7DC-DAAB4B0AD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DA426A4-9AFB-42B0-AA32-BD63B27A96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4869AC3-0E79-4DEA-AED6-CE7C36D91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309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0C3BD10-3A8F-450B-9F11-3D4EC5D55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0F0BC2A-87C8-45EC-A2DB-BC2C6AA6E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653CE4D-2F1C-4492-A968-EC1E41A7F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97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A8FE93-950B-41F9-86C2-AA9B9804CB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7425EF-3996-4828-B64F-09F4AC4158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60CB6CC-BF86-4B6F-9EDC-D7884B3FED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8BF66EA-DAC3-48C2-9622-39000F791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0E4145B-22A8-4CF1-A6B9-E7B7E5E92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E42204-D501-49B6-A096-8BC20DF69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147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E907AE-3478-423B-93AB-7589431DA2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13EBBBA-D1C3-485E-B403-831FC16A70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D1C97BD-F988-4F42-9DC3-479585694D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42359B7-0D89-4C67-854D-EDF5721C3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A4A9870-E521-462E-A13B-35A063DD0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D770401-D65D-4C85-B231-0989B4983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549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14C97CF-E88B-47F2-A3A4-54FA47C19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706DAD9-5486-4801-8A04-455A5A55D8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8DC3E9-85D5-4DBD-9111-4EFA4D9861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1FE9C-BB78-48D0-9CB1-34170E4E9A8A}" type="datetimeFigureOut">
              <a:rPr lang="en-US" smtClean="0"/>
              <a:t>10/30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733879-F976-43DD-96C0-5F4550F0A3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454CA3-905C-4826-B694-DBDF890048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408BD-EB3A-4E4A-B4A2-81ACCDCDB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064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s2199936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CA32490-5F9B-4F0D-844A-CA6D251854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22473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13206608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F03D43E-1B42-41F2-A025-6115B970CB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581" y="980175"/>
            <a:ext cx="11422838" cy="4249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59701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644740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339F744-F564-473B-B4F1-424213335E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00" y="1728035"/>
            <a:ext cx="11953399" cy="3401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44774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1171616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FAF9B33-FE76-4BCB-9D0C-3C5652C2BD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891" y="1129728"/>
            <a:ext cx="9848215" cy="3926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2821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58656183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6A00563-6144-42F7-868C-F1854C30F3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9676" y="451379"/>
            <a:ext cx="5291422" cy="4725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68941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1260326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A0D81D0-ADC8-4220-A1E8-D260F7E168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89056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17300741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05920FC-6373-4DB5-828C-950B15AC1D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9789" y="980175"/>
            <a:ext cx="9392419" cy="4171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07495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1229984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B00B8A9-5599-4567-B850-CEA607929A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17547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149865899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9EFD128-2F76-4D51-9380-FC2AD82FAA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716" y="174811"/>
            <a:ext cx="5476565" cy="50432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34797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28607641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2DCE50D-0DE5-4EF2-AB32-A7CB1E2A1F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7924" y="874234"/>
            <a:ext cx="9236150" cy="4249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37923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3041216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84E281C-841F-41B8-8CEF-39FAF864DC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7630" y="116593"/>
            <a:ext cx="5436740" cy="5006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04092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05B9555-71FF-4339-97A0-71DC58BA8863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s17145750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A52018D-947C-4036-915C-44C137D80A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8171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36</Words>
  <Application>Microsoft Office PowerPoint</Application>
  <PresentationFormat>宽屏</PresentationFormat>
  <Paragraphs>12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8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wen TAO (20617230)</dc:creator>
  <cp:lastModifiedBy>Yiwen TAO (20617230)</cp:lastModifiedBy>
  <cp:revision>2</cp:revision>
  <dcterms:created xsi:type="dcterms:W3CDTF">2024-10-29T14:31:17Z</dcterms:created>
  <dcterms:modified xsi:type="dcterms:W3CDTF">2024-10-30T07:32:09Z</dcterms:modified>
</cp:coreProperties>
</file>